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12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907588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711000" y="744120"/>
            <a:ext cx="537516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124E6DE-6BE9-4F65-9622-627C9254740E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 type="sldImg"/>
          </p:nvPr>
        </p:nvSpPr>
        <p:spPr>
          <a:xfrm>
            <a:off x="711360" y="744480"/>
            <a:ext cx="5375160" cy="3722760"/>
          </a:xfrm>
          <a:prstGeom prst="rect">
            <a:avLst/>
          </a:prstGeom>
          <a:ln w="0">
            <a:noFill/>
          </a:ln>
        </p:spPr>
      </p:sp>
      <p:sp>
        <p:nvSpPr>
          <p:cNvPr id="87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lnSpc>
                <a:spcPct val="10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ox plot in OSC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スライド番号プレースホルダー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ABD404B-72B6-4B2E-B9F9-9224473430AF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DC4411-C184-4346-BAAC-F688C31736A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3443C3-5633-4196-9159-A3472B7059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32BEDC-EFE1-4DDA-B6C7-A2383152488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23244A-26C3-4E6F-AABF-E130B51F755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5AD346-688C-4A03-9A43-06E57267C2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26335A-29AB-4A44-81E4-AFEED215E3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395503-1E40-476E-B3F1-1D7ACA0727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FBC2B2-239B-4933-8F91-E8F2899CDB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D75B90-E8B2-4BDB-A373-B5569C38D8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57FD32-EF0A-436C-AB25-8BBB1F1F32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5FBD79-DD83-46AE-8E1E-98D952F343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39094F-A5D9-4A51-A08A-37874CB483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356520"/>
            <a:ext cx="2311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356520"/>
            <a:ext cx="3136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356520"/>
            <a:ext cx="23115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A3AAD9-E9EB-401A-BAB1-31A4AB6D3F25}" type="slidenum">
              <a: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44"/>
          <p:cNvSpPr/>
          <p:nvPr/>
        </p:nvSpPr>
        <p:spPr>
          <a:xfrm>
            <a:off x="152640" y="139680"/>
            <a:ext cx="23140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.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2" descr="C:\Users\yosuke harazono\Desktop\分子細胞遺伝\cell photo\101111 Panc1 stable8 screening\plate50\655ge.jpg"/>
          <p:cNvPicPr/>
          <p:nvPr/>
        </p:nvPicPr>
        <p:blipFill>
          <a:blip r:embed="rId1"/>
          <a:srcRect l="6299" t="13306" r="7008" b="0"/>
          <a:stretch/>
        </p:blipFill>
        <p:spPr>
          <a:xfrm>
            <a:off x="5713560" y="609480"/>
            <a:ext cx="1193760" cy="90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0" name="Picture 23" descr="C:\Users\yosuke harazono\Desktop\分子細胞遺伝\cell photo\101022 Panc1 stable8 screening\plate4\132ge.jpg"/>
          <p:cNvPicPr/>
          <p:nvPr/>
        </p:nvPicPr>
        <p:blipFill>
          <a:blip r:embed="rId2"/>
          <a:srcRect l="0" t="10451" r="10436" b="0"/>
          <a:stretch/>
        </p:blipFill>
        <p:spPr>
          <a:xfrm>
            <a:off x="4432320" y="1593720"/>
            <a:ext cx="1195200" cy="90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1" name="Picture 25" descr="C:\Users\yosuke harazono\Desktop\分子細胞遺伝\cell photo\101102 Panc1 stable8 screening\101102 Panc1 stable8 screening\plate36\526b☆ge2.jpg"/>
          <p:cNvPicPr/>
          <p:nvPr/>
        </p:nvPicPr>
        <p:blipFill>
          <a:blip r:embed="rId3"/>
          <a:srcRect l="0" t="29933" r="30292" b="0"/>
          <a:stretch/>
        </p:blipFill>
        <p:spPr>
          <a:xfrm>
            <a:off x="5713560" y="1593720"/>
            <a:ext cx="1193760" cy="90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2" name="Picture 2" descr="F:\VAIO desk top\MCG\cell photo\Panc1 GFP\110118 Panc1 GFP validation\302cge.jpg"/>
          <p:cNvPicPr/>
          <p:nvPr/>
        </p:nvPicPr>
        <p:blipFill>
          <a:blip r:embed="rId4"/>
          <a:stretch/>
        </p:blipFill>
        <p:spPr>
          <a:xfrm>
            <a:off x="3152880" y="2577960"/>
            <a:ext cx="1195200" cy="90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3" name="Picture 6" descr="F:\VAIO desk top\MCG\cell photo\Panc1 GFP\110118 Panc1 GFP validation\373ge.jpg"/>
          <p:cNvPicPr/>
          <p:nvPr/>
        </p:nvPicPr>
        <p:blipFill>
          <a:blip r:embed="rId5"/>
          <a:stretch/>
        </p:blipFill>
        <p:spPr>
          <a:xfrm>
            <a:off x="4432320" y="2577960"/>
            <a:ext cx="1195200" cy="90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4" name="Picture 2" descr="C:\Users\yosuke harazono\Desktop\分子細胞遺伝\cell photo\101022 Panc1 stable8 screening\plate12\217ge.jpg"/>
          <p:cNvPicPr/>
          <p:nvPr/>
        </p:nvPicPr>
        <p:blipFill>
          <a:blip r:embed="rId6"/>
          <a:srcRect l="0" t="25927" r="25941" b="0"/>
          <a:stretch/>
        </p:blipFill>
        <p:spPr>
          <a:xfrm>
            <a:off x="5713560" y="2577960"/>
            <a:ext cx="1193760" cy="90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5" name="Picture 6" descr="C:\Users\yosuke harazono\Desktop\分子細胞遺伝\cell photo\101111 Panc1 stable8 screening\plate47\629ge2.jpg"/>
          <p:cNvPicPr/>
          <p:nvPr/>
        </p:nvPicPr>
        <p:blipFill>
          <a:blip r:embed="rId7"/>
          <a:srcRect l="0" t="26718" r="27728" b="0"/>
          <a:stretch/>
        </p:blipFill>
        <p:spPr>
          <a:xfrm>
            <a:off x="3152880" y="3562200"/>
            <a:ext cx="1195200" cy="90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6" name="Picture 3" descr="F:\VAIO desk top\MCG\cell photo\Panc1 GFP\110118 Panc1 GFP validation\302dge.jpg"/>
          <p:cNvPicPr/>
          <p:nvPr/>
        </p:nvPicPr>
        <p:blipFill>
          <a:blip r:embed="rId8"/>
          <a:stretch/>
        </p:blipFill>
        <p:spPr>
          <a:xfrm>
            <a:off x="4432320" y="3562200"/>
            <a:ext cx="1195200" cy="90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7" name="Picture 5" descr="F:\VAIO desk top\MCG\cell photo\Panc1 GFP\110118 Panc1 GFP validation\361-5pge.jpg"/>
          <p:cNvPicPr/>
          <p:nvPr/>
        </p:nvPicPr>
        <p:blipFill>
          <a:blip r:embed="rId9"/>
          <a:stretch/>
        </p:blipFill>
        <p:spPr>
          <a:xfrm>
            <a:off x="5713560" y="3562200"/>
            <a:ext cx="1193760" cy="90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8" name="Picture 4" descr="F:\VAIO desk top\MCG\cell photo\Panc1 GFP\101224 Panc1 stable8 validation\96e.jpg"/>
          <p:cNvPicPr/>
          <p:nvPr/>
        </p:nvPicPr>
        <p:blipFill>
          <a:blip r:embed="rId10"/>
          <a:stretch/>
        </p:blipFill>
        <p:spPr>
          <a:xfrm>
            <a:off x="3152880" y="4548240"/>
            <a:ext cx="1195200" cy="900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9" name="Picture 23" descr="C:\Users\yosuke harazono\Desktop\分子細胞遺伝\cell photo\101022 Panc1 stable8 screening\plate1\139ge.jpg"/>
          <p:cNvPicPr/>
          <p:nvPr/>
        </p:nvPicPr>
        <p:blipFill>
          <a:blip r:embed="rId11"/>
          <a:srcRect l="9427" t="15183" r="6930" b="0"/>
          <a:stretch/>
        </p:blipFill>
        <p:spPr>
          <a:xfrm>
            <a:off x="4432320" y="4548240"/>
            <a:ext cx="1195200" cy="900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0" name="Picture 3" descr="F:\VAIO desk top\MCG\cell photo\Panc1 GFP\101224 Panc1 stable8 validation\183e.jpg"/>
          <p:cNvPicPr/>
          <p:nvPr/>
        </p:nvPicPr>
        <p:blipFill>
          <a:blip r:embed="rId12"/>
          <a:stretch/>
        </p:blipFill>
        <p:spPr>
          <a:xfrm>
            <a:off x="5713560" y="4548240"/>
            <a:ext cx="1193760" cy="900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1" name="Picture 2" descr="C:\Users\yosuke harazono\Desktop\分子細胞遺伝\cell photo\101102 Panc1 stable8 screening\101102 Panc1 stable8 screening\plate34\520d-3pge.jpg"/>
          <p:cNvPicPr/>
          <p:nvPr/>
        </p:nvPicPr>
        <p:blipFill>
          <a:blip r:embed="rId13"/>
          <a:srcRect l="0" t="15807" r="15824" b="0"/>
          <a:stretch/>
        </p:blipFill>
        <p:spPr>
          <a:xfrm>
            <a:off x="3152880" y="5532480"/>
            <a:ext cx="1195200" cy="900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2" name="Picture 2" descr="F:\VAIO desk top\MCG\cell photo\Panc1 GFP\101022 Panc1 stable8 screening\plate7\181dge4.jpg"/>
          <p:cNvPicPr/>
          <p:nvPr/>
        </p:nvPicPr>
        <p:blipFill>
          <a:blip r:embed="rId14"/>
          <a:stretch/>
        </p:blipFill>
        <p:spPr>
          <a:xfrm>
            <a:off x="4432320" y="5532480"/>
            <a:ext cx="1195200" cy="900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3" name="テキスト ボックス 15"/>
          <p:cNvSpPr/>
          <p:nvPr/>
        </p:nvSpPr>
        <p:spPr>
          <a:xfrm>
            <a:off x="6098760" y="1316520"/>
            <a:ext cx="7567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65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15"/>
          <p:cNvSpPr/>
          <p:nvPr/>
        </p:nvSpPr>
        <p:spPr>
          <a:xfrm>
            <a:off x="4607640" y="2300760"/>
            <a:ext cx="966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132-3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15"/>
          <p:cNvSpPr/>
          <p:nvPr/>
        </p:nvSpPr>
        <p:spPr>
          <a:xfrm>
            <a:off x="5801760" y="2300760"/>
            <a:ext cx="1052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526b-3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テキスト ボックス 15"/>
          <p:cNvSpPr/>
          <p:nvPr/>
        </p:nvSpPr>
        <p:spPr>
          <a:xfrm>
            <a:off x="3250080" y="3285000"/>
            <a:ext cx="10447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302c-3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テキスト ボックス 15"/>
          <p:cNvSpPr/>
          <p:nvPr/>
        </p:nvSpPr>
        <p:spPr>
          <a:xfrm>
            <a:off x="4607640" y="3285000"/>
            <a:ext cx="966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373-3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テキスト ボックス 15"/>
          <p:cNvSpPr/>
          <p:nvPr/>
        </p:nvSpPr>
        <p:spPr>
          <a:xfrm>
            <a:off x="6098760" y="3285000"/>
            <a:ext cx="7567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21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テキスト ボックス 15"/>
          <p:cNvSpPr/>
          <p:nvPr/>
        </p:nvSpPr>
        <p:spPr>
          <a:xfrm>
            <a:off x="3327840" y="4269240"/>
            <a:ext cx="966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629-3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テキスト ボックス 15"/>
          <p:cNvSpPr/>
          <p:nvPr/>
        </p:nvSpPr>
        <p:spPr>
          <a:xfrm>
            <a:off x="4521960" y="4269240"/>
            <a:ext cx="1052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302d-3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テキスト ボックス 15"/>
          <p:cNvSpPr/>
          <p:nvPr/>
        </p:nvSpPr>
        <p:spPr>
          <a:xfrm>
            <a:off x="5887800" y="4269240"/>
            <a:ext cx="966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361-5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テキスト ボックス 15"/>
          <p:cNvSpPr/>
          <p:nvPr/>
        </p:nvSpPr>
        <p:spPr>
          <a:xfrm>
            <a:off x="3406680" y="5255280"/>
            <a:ext cx="8892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96-5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テキスト ボックス 15"/>
          <p:cNvSpPr/>
          <p:nvPr/>
        </p:nvSpPr>
        <p:spPr>
          <a:xfrm>
            <a:off x="4607640" y="5255280"/>
            <a:ext cx="966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139-5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テキスト ボックス 15"/>
          <p:cNvSpPr/>
          <p:nvPr/>
        </p:nvSpPr>
        <p:spPr>
          <a:xfrm>
            <a:off x="5887800" y="5255280"/>
            <a:ext cx="966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183-5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テキスト ボックス 15"/>
          <p:cNvSpPr/>
          <p:nvPr/>
        </p:nvSpPr>
        <p:spPr>
          <a:xfrm>
            <a:off x="3242520" y="6239520"/>
            <a:ext cx="1052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520d-3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テキスト ボックス 15"/>
          <p:cNvSpPr/>
          <p:nvPr/>
        </p:nvSpPr>
        <p:spPr>
          <a:xfrm>
            <a:off x="4732560" y="6239520"/>
            <a:ext cx="8420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181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Picture 627" descr="C:\Users\yosuke harazono\Desktop\分子細胞遺伝\cell photo\101022 Panc1 stable8 screening\plate15\200bge.jpg"/>
          <p:cNvPicPr/>
          <p:nvPr/>
        </p:nvPicPr>
        <p:blipFill>
          <a:blip r:embed="rId15"/>
          <a:stretch/>
        </p:blipFill>
        <p:spPr>
          <a:xfrm>
            <a:off x="4432320" y="609480"/>
            <a:ext cx="1195200" cy="90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8" name="Picture 628" descr="C:\Users\yosuke harazono\Desktop\分子細胞遺伝\cell photo\101022 Panc1 stable8 screening\plate15\200cge.jpg"/>
          <p:cNvPicPr/>
          <p:nvPr/>
        </p:nvPicPr>
        <p:blipFill>
          <a:blip r:embed="rId16"/>
          <a:stretch/>
        </p:blipFill>
        <p:spPr>
          <a:xfrm>
            <a:off x="3152880" y="609480"/>
            <a:ext cx="1195200" cy="90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9" name="テキスト ボックス 15"/>
          <p:cNvSpPr/>
          <p:nvPr/>
        </p:nvSpPr>
        <p:spPr>
          <a:xfrm>
            <a:off x="3250080" y="1316520"/>
            <a:ext cx="10447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200c-3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テキスト ボックス 15"/>
          <p:cNvSpPr/>
          <p:nvPr/>
        </p:nvSpPr>
        <p:spPr>
          <a:xfrm>
            <a:off x="4521960" y="1316520"/>
            <a:ext cx="1052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200b-3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Picture 5" descr="C:\Users\yosuke harazono\Desktop\分子細胞遺伝\cell photo\100930 stable8 day4\200age2.jpg"/>
          <p:cNvPicPr/>
          <p:nvPr/>
        </p:nvPicPr>
        <p:blipFill>
          <a:blip r:embed="rId17"/>
          <a:srcRect l="22917" t="21826" r="0" b="0"/>
          <a:stretch/>
        </p:blipFill>
        <p:spPr>
          <a:xfrm>
            <a:off x="3152880" y="1593720"/>
            <a:ext cx="1195200" cy="90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2" name="テキスト ボックス 15"/>
          <p:cNvSpPr/>
          <p:nvPr/>
        </p:nvSpPr>
        <p:spPr>
          <a:xfrm>
            <a:off x="3250080" y="2300760"/>
            <a:ext cx="10447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200a-3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Picture 626" descr="C:\Users\yosuke harazono\Desktop\分子細胞遺伝\cell photo\101022 Panc1 stable8 screening\plate15\ncge.jpg"/>
          <p:cNvPicPr/>
          <p:nvPr/>
        </p:nvPicPr>
        <p:blipFill>
          <a:blip r:embed="rId18"/>
          <a:stretch/>
        </p:blipFill>
        <p:spPr>
          <a:xfrm>
            <a:off x="5713560" y="5532480"/>
            <a:ext cx="1193760" cy="900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4" name="テキスト ボックス 15"/>
          <p:cNvSpPr/>
          <p:nvPr/>
        </p:nvSpPr>
        <p:spPr>
          <a:xfrm>
            <a:off x="6129720" y="6239520"/>
            <a:ext cx="7246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b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ds</a:t>
            </a:r>
            <a:r>
              <a:rPr b="1" i="1" lang="en-US" sz="1100" spc="-1" strike="noStrike">
                <a:solidFill>
                  <a:srgbClr val="ffffff"/>
                </a:solidFill>
                <a:latin typeface="Arial"/>
                <a:ea typeface="HGSｺﾞｼｯｸE"/>
              </a:rPr>
              <a:t>-miR-N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4"/>
          <p:cNvSpPr/>
          <p:nvPr/>
        </p:nvSpPr>
        <p:spPr>
          <a:xfrm>
            <a:off x="8102160" y="169920"/>
            <a:ext cx="1634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Harazono Y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et al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5T04:20:50Z</dcterms:created>
  <dc:creator>yosuke harazono</dc:creator>
  <dc:description/>
  <dc:language>en-US</dc:language>
  <cp:lastModifiedBy>MCG</cp:lastModifiedBy>
  <cp:lastPrinted>2012-08-28T05:49:27Z</cp:lastPrinted>
  <dcterms:modified xsi:type="dcterms:W3CDTF">2013-01-23T04:24:03Z</dcterms:modified>
  <cp:revision>263</cp:revision>
  <dc:subject/>
  <dc:title>PowerPoint プレゼンテーション</dc:title>
</cp:coreProperties>
</file>